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23" autoAdjust="0"/>
    <p:restoredTop sz="88632" autoAdjust="0"/>
  </p:normalViewPr>
  <p:slideViewPr>
    <p:cSldViewPr snapToGrid="0" snapToObjects="1">
      <p:cViewPr>
        <p:scale>
          <a:sx n="70" d="100"/>
          <a:sy n="70" d="100"/>
        </p:scale>
        <p:origin x="-2292" y="5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B3F9F-F21E-493F-BFEA-F1D2D09CFAD3}" type="datetimeFigureOut">
              <a:rPr lang="en-CA" smtClean="0"/>
              <a:pPr/>
              <a:t>22/05/201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345854-6294-413A-9C21-02DA63F77C4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150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345854-6294-413A-9C21-02DA63F77C4A}" type="slidenum">
              <a:rPr lang="en-CA" smtClean="0"/>
              <a:pPr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26958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949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5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9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26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2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3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6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742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1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02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9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6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671712" y="5291771"/>
            <a:ext cx="570702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Fig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formation of cathepsin deficiency in </a:t>
            </a:r>
            <a:r>
              <a:rPr lang="en-CA" sz="1000" b="1" dirty="0">
                <a:latin typeface="Arial" panose="020B0604020202020204" pitchFamily="34" charset="0"/>
                <a:cs typeface="Arial" panose="020B0604020202020204" pitchFamily="34" charset="0"/>
              </a:rPr>
              <a:t>BMMØs.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athepsin B, S, and L mRNA levels in WT, cathepsin B (Cat 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cathepsin S (Cat S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cathepsin L (Cat L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deficient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BMMØ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Average mRNA expression levels quantified by QPCR, are presented relative to WT controls (n=3). mRNA levels normalized to 18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ata presented as mean +/- SEM (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ANOVA, p&lt;0.05); significant differences from WT BMMØs are denoted by asterisks (*). </a:t>
            </a:r>
          </a:p>
          <a:p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 descr="C:\Users\Euan\Desktop\Euan's LAB NEW\Manuscripts\CAT EAE Manuscript\CAT BSL Paper\Prizm FIles\High Res pannels\s1 a catb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5616" y="1254958"/>
            <a:ext cx="1511808" cy="14752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Euan\Desktop\Euan's LAB NEW\Manuscripts\CAT EAE Manuscript\CAT BSL Paper\Prizm FIles\High Res pannels\s1 b cats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4028" y="1254958"/>
            <a:ext cx="1478280" cy="14752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Euan\Desktop\Euan's LAB NEW\Manuscripts\CAT EAE Manuscript\CAT BSL Paper\Prizm FIles\High Res pannels\s1 c catL.tif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2556" y="2730190"/>
            <a:ext cx="1478280" cy="1478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452647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3</TotalTime>
  <Words>88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Euan</cp:lastModifiedBy>
  <cp:revision>1550</cp:revision>
  <dcterms:created xsi:type="dcterms:W3CDTF">2012-09-11T17:14:12Z</dcterms:created>
  <dcterms:modified xsi:type="dcterms:W3CDTF">2015-05-22T19:07:05Z</dcterms:modified>
</cp:coreProperties>
</file>